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jpeg" ContentType="image/jpeg"/>
  <Override PartName="/ppt/media/image5.wmf" ContentType="image/x-wmf"/>
  <Override PartName="/ppt/media/image6.png" ContentType="image/png"/>
  <Override PartName="/ppt/media/image7.gif" ContentType="image/gi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  <p:sldId id="261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B15DF-D156-4CE9-A65D-690B7D32CC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1E0CC-FF54-4937-8946-B96A3C969C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0A04B-BF09-478B-BC47-F8BF4AF35E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88C2C-BCD0-46B8-B368-D56136FBA0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CF595DB-88B6-4728-8B49-F1235DE38D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60AB78B-0651-4E99-8683-5FDC1B9B06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AEEDF4C-03E9-4B53-BBE9-E702AAB944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063347-FA93-4102-B018-9D14177677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24691E0-E0AB-4812-B9A1-ECC6896013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D64218-F895-46C1-B7EC-7355D9B33F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776A9B-B065-478D-AD52-1C09D1D960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36521-5615-4075-934A-856140DAC2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E760D22-C72D-4714-A6B0-FF00136DB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D1FB5B4-9C87-47AC-939D-C2D4759F0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07AA29C-8310-4789-A372-B55E5DC3BA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79E34F1-31B5-458B-9B6C-86D06E5CCF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57995BC-433B-4838-B21C-66D259A169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6BFCA20-DF3B-492D-9FE4-960472FBB0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6A6AA7F-2233-4A44-A0C9-ED6959DBEE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CCB2208-D655-4C05-832D-032A36FDAC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C475B91-56AA-44C5-8D1D-78739E1A2D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8D2CC67-FD35-4983-81FA-C5AD13D9F1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B69EA-9515-4F6E-A729-D5CB8C78DE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3D991CC-7E95-4EF7-BF0C-E711DAFCEE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1E3282C-412F-4412-82C2-B5BB0102D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8826430-63AB-44E1-B5D5-2CE062D896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4595591-3A50-45F3-97EE-F8F7E7AD93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6B8C826-B0FA-4BFD-9504-87008D7CBB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C628084-367B-40DD-BFB4-FA38495573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0605115-262A-4226-B6BB-DFCF481C2C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9E2FB-B727-4F77-809D-571F5F0B93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D821A-188A-45BE-9260-5046680FE9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13D09-3064-479C-98B1-B4D48614DF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8E364-29E5-4345-8029-4D2A180EFC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E5AE5-1BD0-4028-BB56-45E41D8081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7E8F9-8639-496A-BA7E-104AFB57DD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71C59B-0F1E-421F-BD4B-8018B7EDA671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2280C9-099E-45DB-9460-8E95325F183D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AC2C8F-E877-40C4-8783-6B0C264A9A3E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5.wmf"/><Relationship Id="rId3" Type="http://schemas.openxmlformats.org/officeDocument/2006/relationships/image" Target="../media/image5.wmf"/><Relationship Id="rId4" Type="http://schemas.openxmlformats.org/officeDocument/2006/relationships/image" Target="../media/image5.wmf"/><Relationship Id="rId5" Type="http://schemas.openxmlformats.org/officeDocument/2006/relationships/image" Target="../media/image5.wmf"/><Relationship Id="rId6" Type="http://schemas.openxmlformats.org/officeDocument/2006/relationships/image" Target="../media/image5.wmf"/><Relationship Id="rId7" Type="http://schemas.openxmlformats.org/officeDocument/2006/relationships/image" Target="../media/image5.wmf"/><Relationship Id="rId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6.pn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7.gi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Rectangle 9"/>
          <p:cNvSpPr/>
          <p:nvPr/>
        </p:nvSpPr>
        <p:spPr>
          <a:xfrm>
            <a:off x="5638680" y="4419720"/>
            <a:ext cx="1981440" cy="15238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"/>
          <p:cNvSpPr/>
          <p:nvPr/>
        </p:nvSpPr>
        <p:spPr>
          <a:xfrm>
            <a:off x="1447920" y="4419720"/>
            <a:ext cx="1600200" cy="15238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636480" y="1136160"/>
            <a:ext cx="777240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A one-week extension of a ketogenic diet provides a further decrease in myocardial </a:t>
            </a:r>
            <a:r>
              <a:rPr b="1" lang="en-US" sz="22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F-FDG uptake and a high detectability of myocarditis with FDG-PET </a:t>
            </a: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 type="subTitle"/>
          </p:nvPr>
        </p:nvSpPr>
        <p:spPr>
          <a:xfrm>
            <a:off x="636480" y="2514600"/>
            <a:ext cx="7772400" cy="1447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t">
            <a:noAutofit/>
          </a:bodyPr>
          <a:p>
            <a:pPr indent="0" algn="ctr">
              <a:spcBef>
                <a:spcPts val="42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700" spc="-1" strike="noStrike">
                <a:solidFill>
                  <a:srgbClr val="000000"/>
                </a:solidFill>
                <a:latin typeface="Arial"/>
              </a:rPr>
              <a:t>Alexandra Clément, Henri Boutley, Sylvain Poussier, Julien Pierson, Mickael Lhuillier, Allan Kolodziej, Jean-Luc Olivier, Gilles Karcher,  Pierre-Yves Marie, Fatiha Maskali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42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Nancyclotep Experimental Imaging Platform, CHRU-Nancy, 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42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University of Lorraine, France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2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pic>
        <p:nvPicPr>
          <p:cNvPr id="132" name="Image 4" descr=""/>
          <p:cNvPicPr/>
          <p:nvPr/>
        </p:nvPicPr>
        <p:blipFill>
          <a:blip r:embed="rId3"/>
          <a:stretch/>
        </p:blipFill>
        <p:spPr>
          <a:xfrm>
            <a:off x="1531800" y="4460760"/>
            <a:ext cx="1441440" cy="1467000"/>
          </a:xfrm>
          <a:prstGeom prst="rect">
            <a:avLst/>
          </a:prstGeom>
          <a:ln w="0">
            <a:noFill/>
          </a:ln>
        </p:spPr>
      </p:pic>
      <p:pic>
        <p:nvPicPr>
          <p:cNvPr id="133" name="Image 6" descr=""/>
          <p:cNvPicPr/>
          <p:nvPr/>
        </p:nvPicPr>
        <p:blipFill>
          <a:blip r:embed="rId4"/>
          <a:stretch/>
        </p:blipFill>
        <p:spPr>
          <a:xfrm>
            <a:off x="5676840" y="4991040"/>
            <a:ext cx="1905120" cy="37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BACKGROUND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 txBox="1"/>
          <p:nvPr/>
        </p:nvSpPr>
        <p:spPr>
          <a:xfrm>
            <a:off x="419040" y="171252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txBody>
          <a:bodyPr anchor="t">
            <a:normAutofit/>
          </a:bodyPr>
          <a:p>
            <a:pPr algn="just"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hort periods of fasting and/or low carbohydrate diet have been proven beneficial for: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50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decreasing the myocardial uptake of </a:t>
            </a:r>
            <a:r>
              <a:rPr b="0" lang="en-US" sz="22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-fluorodeoxy-glucose (</a:t>
            </a:r>
            <a:r>
              <a:rPr b="0" lang="en-US" sz="22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-FDG)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50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enhancing the detection of inflammatory heart diseases by </a:t>
            </a:r>
            <a:r>
              <a:rPr b="0" lang="en-US" sz="22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-FDG positron emission tomography (PET).</a:t>
            </a: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This study aimed 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at determining whether this benefit is increased when a low-carbohydrate ketogenic diet is prolonged up to 7 days in the rat.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39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</a:rPr>
              <a:t>METHOD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 txBox="1"/>
          <p:nvPr/>
        </p:nvSpPr>
        <p:spPr>
          <a:xfrm>
            <a:off x="533160" y="1676160"/>
            <a:ext cx="8288280" cy="423540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txBody>
          <a:bodyPr anchor="t">
            <a:normAutofit/>
          </a:bodyPr>
          <a:p>
            <a:pPr marL="343080" indent="-343080" algn="just">
              <a:spcBef>
                <a:spcPts val="1199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12 Wistar rats underwent serial </a:t>
            </a:r>
            <a:r>
              <a:rPr b="0" lang="en-US" sz="2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8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F-FDG-PET imaging after an 18-hour fasting period and after 2-, 4- and 7-days of a ketogenic diet (3% carbohydrate)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just">
              <a:spcBef>
                <a:spcPts val="1199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They were compared to 7 rats submitted to the same protocol but with a standard diet (44% carbohydrate).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just">
              <a:spcBef>
                <a:spcPts val="1199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The </a:t>
            </a:r>
            <a:r>
              <a:rPr b="0" lang="en-US" sz="2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8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F-FDG-PET/ketogenic protocol was also applied in 5 rats with immune myocarditis (injection of porcine cardiac myosin).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just">
              <a:spcBef>
                <a:spcPts val="1199"/>
              </a:spcBef>
              <a:buClr>
                <a:srgbClr val="000000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Arial"/>
              </a:rPr>
              <a:t>Animals were finally sacrificed and their hearts excised for histological analyses (HES and Masson’s staining, autohistoradiography and antibody anti-Vimentin).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45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6" name="Espace réservé du contenu 4" descr=""/>
          <p:cNvPicPr/>
          <p:nvPr/>
        </p:nvPicPr>
        <p:blipFill>
          <a:blip r:embed="rId1"/>
          <a:srcRect l="4132" t="7093" r="90261" b="52832"/>
          <a:stretch/>
        </p:blipFill>
        <p:spPr>
          <a:xfrm>
            <a:off x="76320" y="1405080"/>
            <a:ext cx="457200" cy="2550960"/>
          </a:xfrm>
          <a:prstGeom prst="rect">
            <a:avLst/>
          </a:prstGeom>
          <a:ln w="0">
            <a:noFill/>
          </a:ln>
        </p:spPr>
      </p:pic>
      <p:sp>
        <p:nvSpPr>
          <p:cNvPr id="147" name="TextBox 6"/>
          <p:cNvSpPr/>
          <p:nvPr/>
        </p:nvSpPr>
        <p:spPr>
          <a:xfrm>
            <a:off x="349200" y="658188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9" name="Espace réservé du contenu 4" descr=""/>
          <p:cNvPicPr/>
          <p:nvPr/>
        </p:nvPicPr>
        <p:blipFill>
          <a:blip r:embed="rId2"/>
          <a:srcRect l="9132" t="0" r="48169" b="52832"/>
          <a:stretch/>
        </p:blipFill>
        <p:spPr>
          <a:xfrm>
            <a:off x="457200" y="952560"/>
            <a:ext cx="3476520" cy="3003480"/>
          </a:xfrm>
          <a:prstGeom prst="rect">
            <a:avLst/>
          </a:prstGeom>
          <a:ln w="0">
            <a:noFill/>
          </a:ln>
        </p:spPr>
      </p:pic>
      <p:sp>
        <p:nvSpPr>
          <p:cNvPr id="150" name="Rectangle 5"/>
          <p:cNvSpPr/>
          <p:nvPr/>
        </p:nvSpPr>
        <p:spPr>
          <a:xfrm>
            <a:off x="214200" y="4572000"/>
            <a:ext cx="4586400" cy="20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Circulating ketone bodie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Aft>
                <a:spcPts val="1199"/>
              </a:spcAft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exhibited a sustained increase throughout the ketogenic diet period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Aft>
                <a:spcPts val="1199"/>
              </a:spcAft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achieved at the 7th day of ketogenic diet, a level that is as high as that observed after the initial 18-hour fasting.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Espace réservé du contenu 4" descr=""/>
          <p:cNvPicPr/>
          <p:nvPr/>
        </p:nvPicPr>
        <p:blipFill>
          <a:blip r:embed="rId3"/>
          <a:srcRect l="21709" t="47176" r="31454" b="48548"/>
          <a:stretch/>
        </p:blipFill>
        <p:spPr>
          <a:xfrm>
            <a:off x="1143000" y="3917880"/>
            <a:ext cx="4533840" cy="324000"/>
          </a:xfrm>
          <a:prstGeom prst="rect">
            <a:avLst/>
          </a:prstGeom>
          <a:ln w="0">
            <a:noFill/>
          </a:ln>
        </p:spPr>
      </p:pic>
      <p:pic>
        <p:nvPicPr>
          <p:cNvPr id="152" name="Espace réservé du contenu 4" descr=""/>
          <p:cNvPicPr/>
          <p:nvPr/>
        </p:nvPicPr>
        <p:blipFill>
          <a:blip r:embed="rId4"/>
          <a:srcRect l="10651" t="51364" r="46650" b="6646"/>
          <a:stretch/>
        </p:blipFill>
        <p:spPr>
          <a:xfrm>
            <a:off x="4910040" y="1295280"/>
            <a:ext cx="3476880" cy="2673360"/>
          </a:xfrm>
          <a:prstGeom prst="rect">
            <a:avLst/>
          </a:prstGeom>
          <a:ln w="0">
            <a:noFill/>
          </a:ln>
        </p:spPr>
      </p:pic>
      <p:pic>
        <p:nvPicPr>
          <p:cNvPr id="153" name="Espace réservé du contenu 4" descr=""/>
          <p:cNvPicPr/>
          <p:nvPr/>
        </p:nvPicPr>
        <p:blipFill>
          <a:blip r:embed="rId5"/>
          <a:srcRect l="21709" t="47176" r="31454" b="48548"/>
          <a:stretch/>
        </p:blipFill>
        <p:spPr>
          <a:xfrm>
            <a:off x="5904000" y="3895560"/>
            <a:ext cx="4535280" cy="324000"/>
          </a:xfrm>
          <a:prstGeom prst="rect">
            <a:avLst/>
          </a:prstGeom>
          <a:ln w="0">
            <a:noFill/>
          </a:ln>
        </p:spPr>
      </p:pic>
      <p:pic>
        <p:nvPicPr>
          <p:cNvPr id="154" name="Espace réservé du contenu 4" descr=""/>
          <p:cNvPicPr/>
          <p:nvPr/>
        </p:nvPicPr>
        <p:blipFill>
          <a:blip r:embed="rId6"/>
          <a:srcRect l="5613" t="52409" r="85973" b="13236"/>
          <a:stretch/>
        </p:blipFill>
        <p:spPr>
          <a:xfrm>
            <a:off x="4522680" y="1371600"/>
            <a:ext cx="685800" cy="2187720"/>
          </a:xfrm>
          <a:prstGeom prst="rect">
            <a:avLst/>
          </a:prstGeom>
          <a:ln w="0">
            <a:noFill/>
          </a:ln>
        </p:spPr>
      </p:pic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57200" y="762120"/>
            <a:ext cx="8229600" cy="566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1"/>
          <p:cNvSpPr/>
          <p:nvPr/>
        </p:nvSpPr>
        <p:spPr>
          <a:xfrm>
            <a:off x="1092240" y="4203720"/>
            <a:ext cx="845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*: p&lt;0.05 for 2-group comparisons and Ϯ: p&lt;0.05 paired comparisons with 18-hour fast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2"/>
          <p:cNvSpPr/>
          <p:nvPr/>
        </p:nvSpPr>
        <p:spPr>
          <a:xfrm>
            <a:off x="4660920" y="4549680"/>
            <a:ext cx="4483080" cy="21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yocardial 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-FDG uptake,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ssessed through myocardial-to-blood activity ratio: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xhibited a gradual decline throughout the ketogenic diet period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aching a lower level at the 7th day than that documented with the initial 18-hour fasting perio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Espace réservé du contenu 4" descr=""/>
          <p:cNvPicPr/>
          <p:nvPr/>
        </p:nvPicPr>
        <p:blipFill>
          <a:blip r:embed="rId7"/>
          <a:srcRect l="51913" t="1939" r="31254" b="88280"/>
          <a:stretch/>
        </p:blipFill>
        <p:spPr>
          <a:xfrm>
            <a:off x="6648480" y="911160"/>
            <a:ext cx="1339920" cy="609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63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Image 1" descr=""/>
          <p:cNvPicPr/>
          <p:nvPr/>
        </p:nvPicPr>
        <p:blipFill>
          <a:blip r:embed="rId3"/>
          <a:srcRect l="0" t="0" r="0" b="91152"/>
          <a:stretch/>
        </p:blipFill>
        <p:spPr>
          <a:xfrm>
            <a:off x="673200" y="1386000"/>
            <a:ext cx="6861240" cy="463320"/>
          </a:xfrm>
          <a:prstGeom prst="rect">
            <a:avLst/>
          </a:prstGeom>
          <a:ln w="0">
            <a:noFill/>
          </a:ln>
        </p:spPr>
      </p:pic>
      <p:sp>
        <p:nvSpPr>
          <p:cNvPr id="165" name="Rectangle 2"/>
          <p:cNvSpPr/>
          <p:nvPr/>
        </p:nvSpPr>
        <p:spPr>
          <a:xfrm>
            <a:off x="442800" y="5122800"/>
            <a:ext cx="87105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 combined in vivo and ex-vivo analysis demonstrated that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yocardial areas with high 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18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F-FDG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uptake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rresponded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 sub-acute myocarditis (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→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, with increased fibrosis and inflammatory infiltrate,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 a normal ringlike area (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→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urrently documented around mitral annulu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6" name="Image 1" descr=""/>
          <p:cNvPicPr/>
          <p:nvPr/>
        </p:nvPicPr>
        <p:blipFill>
          <a:blip r:embed="rId4"/>
          <a:srcRect l="0" t="37073" r="0" b="0"/>
          <a:stretch/>
        </p:blipFill>
        <p:spPr>
          <a:xfrm>
            <a:off x="682560" y="1849320"/>
            <a:ext cx="6861240" cy="3292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</a:rPr>
              <a:t>CONCLUSION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 txBox="1"/>
          <p:nvPr/>
        </p:nvSpPr>
        <p:spPr>
          <a:xfrm>
            <a:off x="476280" y="1405080"/>
            <a:ext cx="8305920" cy="43797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0000"/>
          </a:bodyPr>
          <a:p>
            <a:pPr>
              <a:spcBef>
                <a:spcPts val="11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n rats, a one-week extension of a ketogenic diet provides: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 further decrease in the </a:t>
            </a:r>
            <a:r>
              <a:rPr b="0" lang="en-US" sz="2400" spc="-1" strike="noStrike" baseline="30000">
                <a:solidFill>
                  <a:srgbClr val="000000"/>
                </a:solidFill>
                <a:latin typeface="Arial"/>
              </a:rPr>
              <a:t>18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-FDG uptake of normal myocardium,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 high detectability of inflammatory area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Clinical trials, assessing prolonged ketogenic diets alone or in association with tolerable fasting periods, are warranted. 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75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6"/>
          <p:cNvSpPr/>
          <p:nvPr/>
        </p:nvSpPr>
        <p:spPr>
          <a:xfrm>
            <a:off x="501840" y="637848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0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72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3" name="Image 1" descr=""/>
          <p:cNvPicPr/>
          <p:nvPr/>
        </p:nvPicPr>
        <p:blipFill>
          <a:blip r:embed="rId3"/>
          <a:stretch/>
        </p:blipFill>
        <p:spPr>
          <a:xfrm>
            <a:off x="388800" y="3930480"/>
            <a:ext cx="5867640" cy="1327320"/>
          </a:xfrm>
          <a:prstGeom prst="rect">
            <a:avLst/>
          </a:prstGeom>
          <a:ln w="0">
            <a:noFill/>
          </a:ln>
        </p:spPr>
      </p:pic>
      <p:sp>
        <p:nvSpPr>
          <p:cNvPr id="174" name="ZoneTexte 2"/>
          <p:cNvSpPr/>
          <p:nvPr/>
        </p:nvSpPr>
        <p:spPr>
          <a:xfrm>
            <a:off x="1026000" y="3316320"/>
            <a:ext cx="180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Myocarditis r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ZoneTexte 9"/>
          <p:cNvSpPr/>
          <p:nvPr/>
        </p:nvSpPr>
        <p:spPr>
          <a:xfrm>
            <a:off x="4070880" y="332892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Normal r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ZoneTexte 11"/>
          <p:cNvSpPr/>
          <p:nvPr/>
        </p:nvSpPr>
        <p:spPr>
          <a:xfrm>
            <a:off x="904320" y="3656160"/>
            <a:ext cx="56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VL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ZoneTexte 13"/>
          <p:cNvSpPr/>
          <p:nvPr/>
        </p:nvSpPr>
        <p:spPr>
          <a:xfrm>
            <a:off x="2350800" y="36450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HL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Connecteur droit 5"/>
          <p:cNvSpPr/>
          <p:nvPr/>
        </p:nvSpPr>
        <p:spPr>
          <a:xfrm>
            <a:off x="565200" y="3697200"/>
            <a:ext cx="2584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ZoneTexte 17"/>
          <p:cNvSpPr/>
          <p:nvPr/>
        </p:nvSpPr>
        <p:spPr>
          <a:xfrm>
            <a:off x="3793320" y="3651120"/>
            <a:ext cx="56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VL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ZoneTexte 18"/>
          <p:cNvSpPr/>
          <p:nvPr/>
        </p:nvSpPr>
        <p:spPr>
          <a:xfrm>
            <a:off x="5240160" y="363852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HL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Connecteur droit 19"/>
          <p:cNvSpPr/>
          <p:nvPr/>
        </p:nvSpPr>
        <p:spPr>
          <a:xfrm>
            <a:off x="3454560" y="3692520"/>
            <a:ext cx="2584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21"/>
          <p:cNvSpPr/>
          <p:nvPr/>
        </p:nvSpPr>
        <p:spPr>
          <a:xfrm>
            <a:off x="6734160" y="3930480"/>
            <a:ext cx="1871640" cy="10692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myocarditis foci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1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normal ringlike uptake at LV b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22"/>
          <p:cNvSpPr/>
          <p:nvPr/>
        </p:nvSpPr>
        <p:spPr>
          <a:xfrm>
            <a:off x="6424560" y="3930480"/>
            <a:ext cx="385920" cy="368280"/>
          </a:xfrm>
          <a:prstGeom prst="rect">
            <a:avLst/>
          </a:prstGeom>
          <a:solidFill>
            <a:srgbClr val="00808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  <a:ea typeface="Calibri"/>
              </a:rPr>
              <a:t>→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23"/>
          <p:cNvSpPr/>
          <p:nvPr/>
        </p:nvSpPr>
        <p:spPr>
          <a:xfrm>
            <a:off x="6424560" y="4370400"/>
            <a:ext cx="385920" cy="368280"/>
          </a:xfrm>
          <a:prstGeom prst="rect">
            <a:avLst/>
          </a:prstGeom>
          <a:solidFill>
            <a:srgbClr val="00808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→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Fatiha MASKALI</cp:lastModifiedBy>
  <dcterms:modified xsi:type="dcterms:W3CDTF">2018-07-26T13:20:00Z</dcterms:modified>
  <cp:revision>139</cp:revision>
  <dc:subject/>
  <dc:title>Slide 1</dc:title>
</cp:coreProperties>
</file>